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9" r:id="rId2"/>
    <p:sldId id="263" r:id="rId3"/>
    <p:sldId id="264" r:id="rId4"/>
    <p:sldId id="266" r:id="rId5"/>
    <p:sldId id="267" r:id="rId6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4CF2999-38F9-149B-8158-97923B3D2903}" name="John Francis Murphy" initials="JM" userId="S::btw374@qmul.ac.uk::b29f9a3e-aa68-4af9-a79a-c63d8cb6dc6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0"/>
  </p:normalViewPr>
  <p:slideViewPr>
    <p:cSldViewPr snapToGrid="0">
      <p:cViewPr>
        <p:scale>
          <a:sx n="120" d="100"/>
          <a:sy n="120" d="100"/>
        </p:scale>
        <p:origin x="924" y="-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te Mathers" userId="4d07b8d5-1443-4e4a-88c9-95afa2dd68c5" providerId="ADAL" clId="{6AEA08B4-28C3-4B1A-8F8A-4B5051C88EE9}"/>
    <pc:docChg chg="delSld">
      <pc:chgData name="Kate Mathers" userId="4d07b8d5-1443-4e4a-88c9-95afa2dd68c5" providerId="ADAL" clId="{6AEA08B4-28C3-4B1A-8F8A-4B5051C88EE9}" dt="2024-11-20T13:11:13.669" v="0" actId="47"/>
      <pc:docMkLst>
        <pc:docMk/>
      </pc:docMkLst>
      <pc:sldChg chg="del">
        <pc:chgData name="Kate Mathers" userId="4d07b8d5-1443-4e4a-88c9-95afa2dd68c5" providerId="ADAL" clId="{6AEA08B4-28C3-4B1A-8F8A-4B5051C88EE9}" dt="2024-11-20T13:11:13.669" v="0" actId="47"/>
        <pc:sldMkLst>
          <pc:docMk/>
          <pc:sldMk cId="40977641" sldId="265"/>
        </pc:sldMkLst>
      </pc:sldChg>
    </pc:docChg>
  </pc:docChgLst>
  <pc:docChgLst>
    <pc:chgData name="Kate Mathers" userId="4d07b8d5-1443-4e4a-88c9-95afa2dd68c5" providerId="ADAL" clId="{82E9854A-8CDA-4512-9050-C4696F69761A}"/>
    <pc:docChg chg="modSld">
      <pc:chgData name="Kate Mathers" userId="4d07b8d5-1443-4e4a-88c9-95afa2dd68c5" providerId="ADAL" clId="{82E9854A-8CDA-4512-9050-C4696F69761A}" dt="2025-10-31T13:14:58.171" v="0" actId="20577"/>
      <pc:docMkLst>
        <pc:docMk/>
      </pc:docMkLst>
      <pc:sldChg chg="modSp mod">
        <pc:chgData name="Kate Mathers" userId="4d07b8d5-1443-4e4a-88c9-95afa2dd68c5" providerId="ADAL" clId="{82E9854A-8CDA-4512-9050-C4696F69761A}" dt="2025-10-31T13:14:58.171" v="0" actId="20577"/>
        <pc:sldMkLst>
          <pc:docMk/>
          <pc:sldMk cId="2467208768" sldId="266"/>
        </pc:sldMkLst>
        <pc:graphicFrameChg chg="modGraphic">
          <ac:chgData name="Kate Mathers" userId="4d07b8d5-1443-4e4a-88c9-95afa2dd68c5" providerId="ADAL" clId="{82E9854A-8CDA-4512-9050-C4696F69761A}" dt="2025-10-31T13:14:58.171" v="0" actId="20577"/>
          <ac:graphicFrameMkLst>
            <pc:docMk/>
            <pc:sldMk cId="2467208768" sldId="266"/>
            <ac:graphicFrameMk id="4" creationId="{D5B92228-F8F7-AC9D-CCE3-E9E145A01CB2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0F3559-2ED8-4338-A564-4C15227F52A6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B54519-1DB9-4193-9049-89D42EB0F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956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B54519-1DB9-4193-9049-89D42EB0FC36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95309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B54519-1DB9-4193-9049-89D42EB0FC36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02695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910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9463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1389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09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7146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2214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020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6999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198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170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4306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07F290-4B9D-4A62-96F8-53B2F0B48B34}" type="datetimeFigureOut">
              <a:rPr lang="en-GB" smtClean="0"/>
              <a:t>2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74170E-3CC1-4A0F-8418-F282B857A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6394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4C9AEB8-D5B6-9269-25F6-BD8901E726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6036144"/>
              </p:ext>
            </p:extLst>
          </p:nvPr>
        </p:nvGraphicFramePr>
        <p:xfrm>
          <a:off x="496944" y="262259"/>
          <a:ext cx="5864119" cy="8619525"/>
        </p:xfrm>
        <a:graphic>
          <a:graphicData uri="http://schemas.openxmlformats.org/drawingml/2006/table">
            <a:tbl>
              <a:tblPr/>
              <a:tblGrid>
                <a:gridCol w="1591572">
                  <a:extLst>
                    <a:ext uri="{9D8B030D-6E8A-4147-A177-3AD203B41FA5}">
                      <a16:colId xmlns:a16="http://schemas.microsoft.com/office/drawing/2014/main" val="2543723649"/>
                    </a:ext>
                  </a:extLst>
                </a:gridCol>
                <a:gridCol w="1591572">
                  <a:extLst>
                    <a:ext uri="{9D8B030D-6E8A-4147-A177-3AD203B41FA5}">
                      <a16:colId xmlns:a16="http://schemas.microsoft.com/office/drawing/2014/main" val="346421941"/>
                    </a:ext>
                  </a:extLst>
                </a:gridCol>
                <a:gridCol w="1339116">
                  <a:extLst>
                    <a:ext uri="{9D8B030D-6E8A-4147-A177-3AD203B41FA5}">
                      <a16:colId xmlns:a16="http://schemas.microsoft.com/office/drawing/2014/main" val="1809507094"/>
                    </a:ext>
                  </a:extLst>
                </a:gridCol>
                <a:gridCol w="1341859">
                  <a:extLst>
                    <a:ext uri="{9D8B030D-6E8A-4147-A177-3AD203B41FA5}">
                      <a16:colId xmlns:a16="http://schemas.microsoft.com/office/drawing/2014/main" val="219733266"/>
                    </a:ext>
                  </a:extLst>
                </a:gridCol>
              </a:tblGrid>
              <a:tr h="370575">
                <a:tc gridSpan="4"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1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croinvertebrate functional traits examined within this study (taken from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he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t al., 2010).</a:t>
                      </a: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3040092"/>
                  </a:ext>
                </a:extLst>
              </a:tr>
              <a:tr h="1876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ing featur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ing featur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127089"/>
                  </a:ext>
                </a:extLst>
              </a:tr>
              <a:tr h="187695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imum potential siz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0.25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iration method 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l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46469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0.25- 0.5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tr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581924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0.5- 1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iracl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8054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- 2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static vesicl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004741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2- 4 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gumen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362799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4- 8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consumed 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roorganism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695267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8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tritus &lt;1m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141045"/>
                  </a:ext>
                </a:extLst>
              </a:tr>
              <a:tr h="18769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fe-cycle dur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1 yea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ad plant ≥1m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97341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 yea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icrophy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7886277"/>
                  </a:ext>
                </a:extLst>
              </a:tr>
              <a:tr h="187695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tinis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1 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acrophty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60943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ad animal ≥1m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8769859"/>
                  </a:ext>
                </a:extLst>
              </a:tr>
              <a:tr h="37057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 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icroinvertebra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995362"/>
                  </a:ext>
                </a:extLst>
              </a:tr>
              <a:tr h="18769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stage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g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invertebra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138628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va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tebra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284149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ymph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eding group 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sorb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443302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posit feed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02694"/>
                  </a:ext>
                </a:extLst>
              </a:tr>
              <a:tr h="187695"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roduction strategy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oviviparity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redd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40712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ated, free egg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rap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467215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ated, cemented egg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ter-feed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21776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cemented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erc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2864982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fre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ato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31373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in veget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sit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197452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terrestria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14">
                  <a:txBody>
                    <a:bodyPr/>
                    <a:lstStyle/>
                    <a:p>
                      <a:pPr algn="ctr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834312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exua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1022561"/>
                  </a:ext>
                </a:extLst>
              </a:tr>
              <a:tr h="18769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persal strategy 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pass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324967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act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523875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ial pass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573069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ial act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8657322"/>
                  </a:ext>
                </a:extLst>
              </a:tr>
              <a:tr h="187695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istance for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gs/statoblast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216288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coon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134096"/>
                  </a:ext>
                </a:extLst>
              </a:tr>
              <a:tr h="37057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usings against desicc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55619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pause / dormancy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390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8343360"/>
                  </a:ext>
                </a:extLst>
              </a:tr>
              <a:tr h="187695"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omotion and substrate rel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i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35724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swimm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690535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ll water swimm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822041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awl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102127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rrow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8113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stitia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5931577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mporarily attached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21298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manently attached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7867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21400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graph of different types of minerals&#10;&#10;Description automatically generated">
            <a:extLst>
              <a:ext uri="{FF2B5EF4-FFF2-40B4-BE49-F238E27FC236}">
                <a16:creationId xmlns:a16="http://schemas.microsoft.com/office/drawing/2014/main" id="{DB0CBA0F-FC6A-6097-F12E-E0089691D9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59" y="87131"/>
            <a:ext cx="3373341" cy="3438939"/>
          </a:xfrm>
          <a:prstGeom prst="rect">
            <a:avLst/>
          </a:prstGeom>
        </p:spPr>
      </p:pic>
      <p:pic>
        <p:nvPicPr>
          <p:cNvPr id="14" name="Picture 13" descr="A graph of different sizes and colors&#10;&#10;Description automatically generated with medium confidence">
            <a:extLst>
              <a:ext uri="{FF2B5EF4-FFF2-40B4-BE49-F238E27FC236}">
                <a16:creationId xmlns:a16="http://schemas.microsoft.com/office/drawing/2014/main" id="{C18009E2-8444-EF22-DC45-035A126D8F2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3549261"/>
            <a:ext cx="3323644" cy="3323644"/>
          </a:xfrm>
          <a:prstGeom prst="rect">
            <a:avLst/>
          </a:prstGeom>
        </p:spPr>
      </p:pic>
      <p:pic>
        <p:nvPicPr>
          <p:cNvPr id="16" name="Picture 15" descr="A graph of different types of minerals&#10;&#10;Description automatically generated">
            <a:extLst>
              <a:ext uri="{FF2B5EF4-FFF2-40B4-BE49-F238E27FC236}">
                <a16:creationId xmlns:a16="http://schemas.microsoft.com/office/drawing/2014/main" id="{D8186D45-2E85-5483-FF49-FFC1E96DC83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500" y="63939"/>
            <a:ext cx="3504206" cy="3504206"/>
          </a:xfrm>
          <a:prstGeom prst="rect">
            <a:avLst/>
          </a:prstGeom>
        </p:spPr>
      </p:pic>
      <p:pic>
        <p:nvPicPr>
          <p:cNvPr id="18" name="Picture 17" descr="A graph of different types of minerals&#10;&#10;Description automatically generated">
            <a:extLst>
              <a:ext uri="{FF2B5EF4-FFF2-40B4-BE49-F238E27FC236}">
                <a16:creationId xmlns:a16="http://schemas.microsoft.com/office/drawing/2014/main" id="{CF4A41A9-5411-CDA3-586D-3111AE03458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500" y="3526070"/>
            <a:ext cx="3504205" cy="350420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F6E0DE7-BA62-A640-27B7-8979BA8846B0}"/>
              </a:ext>
            </a:extLst>
          </p:cNvPr>
          <p:cNvSpPr txBox="1"/>
          <p:nvPr/>
        </p:nvSpPr>
        <p:spPr>
          <a:xfrm>
            <a:off x="263055" y="7053466"/>
            <a:ext cx="633189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. </a:t>
            </a:r>
            <a:r>
              <a:rPr lang="en-GB" sz="1200" dirty="0"/>
              <a:t>Individual response plots from Threshold Indicator Taxa </a:t>
            </a:r>
            <a:r>
              <a:rPr lang="en-GB" sz="1200" dirty="0" err="1"/>
              <a:t>ANalysis</a:t>
            </a:r>
            <a:r>
              <a:rPr lang="en-GB" sz="1200" dirty="0"/>
              <a:t> (TITAN2) along the deposited fine sediment gradient (% visual cover) for spring data only </a:t>
            </a:r>
            <a:r>
              <a:rPr lang="en-GB" sz="1200" dirty="0">
                <a:effectLst/>
                <a:ea typeface="Aptos" panose="020B0004020202020204" pitchFamily="34" charset="0"/>
              </a:rPr>
              <a:t>for a) lowland calcareous b) lowland silicious, c) mid-altitude calcareous and d) mid-altitude silicious</a:t>
            </a:r>
            <a:r>
              <a:rPr lang="en-GB" sz="1200" dirty="0"/>
              <a:t>. Taxa that responded negatively to the gradient are shown in red, while positive indicator taxa are shown with blue. Taxa change points (across 999 bootstrapped replicates) are visualized as a probability density function with colour intensity scaled according to the magnitude of the response (</a:t>
            </a:r>
            <a:r>
              <a:rPr lang="en-GB" sz="1200" dirty="0" err="1"/>
              <a:t>i</a:t>
            </a:r>
            <a:r>
              <a:rPr lang="en-GB" sz="1200" dirty="0"/>
              <a:t>. e., its standardized z-score)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C9F6D19-459D-73C1-3BB1-D67D9902CEEE}"/>
              </a:ext>
            </a:extLst>
          </p:cNvPr>
          <p:cNvSpPr txBox="1"/>
          <p:nvPr/>
        </p:nvSpPr>
        <p:spPr>
          <a:xfrm>
            <a:off x="50245" y="69571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66279A2-340E-D82E-7719-2F448331BE03}"/>
              </a:ext>
            </a:extLst>
          </p:cNvPr>
          <p:cNvSpPr txBox="1"/>
          <p:nvPr/>
        </p:nvSpPr>
        <p:spPr>
          <a:xfrm>
            <a:off x="3254797" y="69571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DB04BB-16AD-0CE1-BA42-75AFD31B1DDB}"/>
              </a:ext>
            </a:extLst>
          </p:cNvPr>
          <p:cNvSpPr txBox="1"/>
          <p:nvPr/>
        </p:nvSpPr>
        <p:spPr>
          <a:xfrm>
            <a:off x="50245" y="3625214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F377D3-BDC3-A879-327B-5339FB6E6593}"/>
              </a:ext>
            </a:extLst>
          </p:cNvPr>
          <p:cNvSpPr txBox="1"/>
          <p:nvPr/>
        </p:nvSpPr>
        <p:spPr>
          <a:xfrm>
            <a:off x="3254797" y="3609118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7623204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graph of different types of minerals&#10;&#10;Description automatically generated">
            <a:extLst>
              <a:ext uri="{FF2B5EF4-FFF2-40B4-BE49-F238E27FC236}">
                <a16:creationId xmlns:a16="http://schemas.microsoft.com/office/drawing/2014/main" id="{0BA82C1E-E021-876A-4773-CF5A60EDFA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2"/>
          <a:stretch/>
        </p:blipFill>
        <p:spPr>
          <a:xfrm>
            <a:off x="32262" y="198783"/>
            <a:ext cx="3328162" cy="3468342"/>
          </a:xfrm>
          <a:prstGeom prst="rect">
            <a:avLst/>
          </a:prstGeom>
        </p:spPr>
      </p:pic>
      <p:pic>
        <p:nvPicPr>
          <p:cNvPr id="12" name="Picture 11" descr="A graph of different sizes and colors&#10;&#10;Description automatically generated">
            <a:extLst>
              <a:ext uri="{FF2B5EF4-FFF2-40B4-BE49-F238E27FC236}">
                <a16:creationId xmlns:a16="http://schemas.microsoft.com/office/drawing/2014/main" id="{7C17CE82-2D96-FBD4-2E5E-D557BD08AC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62" y="3895199"/>
            <a:ext cx="3066292" cy="3066292"/>
          </a:xfrm>
          <a:prstGeom prst="rect">
            <a:avLst/>
          </a:prstGeom>
        </p:spPr>
      </p:pic>
      <p:pic>
        <p:nvPicPr>
          <p:cNvPr id="14" name="Picture 13" descr="A graph of different types of minerals&#10;&#10;Description automatically generated">
            <a:extLst>
              <a:ext uri="{FF2B5EF4-FFF2-40B4-BE49-F238E27FC236}">
                <a16:creationId xmlns:a16="http://schemas.microsoft.com/office/drawing/2014/main" id="{0A1C56AF-4586-D4AF-6DBC-A532E4FB10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334" y="150252"/>
            <a:ext cx="3565404" cy="3565404"/>
          </a:xfrm>
          <a:prstGeom prst="rect">
            <a:avLst/>
          </a:prstGeom>
        </p:spPr>
      </p:pic>
      <p:pic>
        <p:nvPicPr>
          <p:cNvPr id="16" name="Picture 15" descr="A graph of different types of minerals&#10;&#10;Description automatically generated">
            <a:extLst>
              <a:ext uri="{FF2B5EF4-FFF2-40B4-BE49-F238E27FC236}">
                <a16:creationId xmlns:a16="http://schemas.microsoft.com/office/drawing/2014/main" id="{C3C8B620-613C-071E-98E2-8071F6A123E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0424" y="3695688"/>
            <a:ext cx="3465314" cy="346531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3152C88-D360-187A-136E-A192E7A7FE5B}"/>
              </a:ext>
            </a:extLst>
          </p:cNvPr>
          <p:cNvSpPr txBox="1"/>
          <p:nvPr/>
        </p:nvSpPr>
        <p:spPr>
          <a:xfrm>
            <a:off x="263055" y="7261092"/>
            <a:ext cx="633189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2. </a:t>
            </a:r>
            <a:r>
              <a:rPr lang="en-GB" sz="1200" dirty="0"/>
              <a:t>Individual response plots from Threshold Indicator Taxa </a:t>
            </a:r>
            <a:r>
              <a:rPr lang="en-GB" sz="1200" dirty="0" err="1"/>
              <a:t>ANalysis</a:t>
            </a:r>
            <a:r>
              <a:rPr lang="en-GB" sz="1200" dirty="0"/>
              <a:t> (TITAN2) along the deposited fine sediment gradient (% visual cover) for Autumn data only </a:t>
            </a:r>
            <a:r>
              <a:rPr lang="en-GB" sz="1200" dirty="0">
                <a:effectLst/>
                <a:ea typeface="Aptos" panose="020B0004020202020204" pitchFamily="34" charset="0"/>
              </a:rPr>
              <a:t>for a) lowland calcareous b) lowland silicious, c) mid-altitude calcareous and d) mid-altitude silicious</a:t>
            </a:r>
            <a:r>
              <a:rPr lang="en-GB" sz="1200" dirty="0"/>
              <a:t>. Taxa that responded negatively to the gradient are shown in red, while positive indicator taxa are shown with blue. Taxa change points (across 999 bootstrapped replicates) are visualized as a probability density function with colour intensity scaled according to the magnitude of the response (</a:t>
            </a:r>
            <a:r>
              <a:rPr lang="en-GB" sz="1200" dirty="0" err="1"/>
              <a:t>i</a:t>
            </a:r>
            <a:r>
              <a:rPr lang="en-GB" sz="1200" dirty="0"/>
              <a:t>. e., its standardized z-score)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2EE64F-4596-54B0-1A6A-D8EF81E5F82F}"/>
              </a:ext>
            </a:extLst>
          </p:cNvPr>
          <p:cNvSpPr txBox="1"/>
          <p:nvPr/>
        </p:nvSpPr>
        <p:spPr>
          <a:xfrm>
            <a:off x="50245" y="69571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493EDC6-8A3D-0409-3BEF-3831CFF754B0}"/>
              </a:ext>
            </a:extLst>
          </p:cNvPr>
          <p:cNvSpPr txBox="1"/>
          <p:nvPr/>
        </p:nvSpPr>
        <p:spPr>
          <a:xfrm>
            <a:off x="3254797" y="69571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BFC96A-AB2B-5DC1-C3C4-504B193D7912}"/>
              </a:ext>
            </a:extLst>
          </p:cNvPr>
          <p:cNvSpPr txBox="1"/>
          <p:nvPr/>
        </p:nvSpPr>
        <p:spPr>
          <a:xfrm>
            <a:off x="50245" y="3625214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FAB314-C115-05C1-4CB6-2A26516FEAF4}"/>
              </a:ext>
            </a:extLst>
          </p:cNvPr>
          <p:cNvSpPr txBox="1"/>
          <p:nvPr/>
        </p:nvSpPr>
        <p:spPr>
          <a:xfrm>
            <a:off x="3254797" y="3609118"/>
            <a:ext cx="427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2745179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5B92228-F8F7-AC9D-CCE3-E9E145A01C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9090886"/>
              </p:ext>
            </p:extLst>
          </p:nvPr>
        </p:nvGraphicFramePr>
        <p:xfrm>
          <a:off x="423118" y="108337"/>
          <a:ext cx="5984504" cy="3098483"/>
        </p:xfrm>
        <a:graphic>
          <a:graphicData uri="http://schemas.openxmlformats.org/drawingml/2006/table">
            <a:tbl>
              <a:tblPr firstRow="1" firstCol="1" bandRow="1"/>
              <a:tblGrid>
                <a:gridCol w="1196768">
                  <a:extLst>
                    <a:ext uri="{9D8B030D-6E8A-4147-A177-3AD203B41FA5}">
                      <a16:colId xmlns:a16="http://schemas.microsoft.com/office/drawing/2014/main" val="4232028763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3679117407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2645443702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4174454675"/>
                    </a:ext>
                  </a:extLst>
                </a:gridCol>
                <a:gridCol w="1197432">
                  <a:extLst>
                    <a:ext uri="{9D8B030D-6E8A-4147-A177-3AD203B41FA5}">
                      <a16:colId xmlns:a16="http://schemas.microsoft.com/office/drawing/2014/main" val="207507030"/>
                    </a:ext>
                  </a:extLst>
                </a:gridCol>
              </a:tblGrid>
              <a:tr h="79660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ble S2. 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rwise correlation coefficient between 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xonomic and functional community measures a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d visual fine sediment %. Correlations have been corrected for multiple comparisons using the Holm-</a:t>
                      </a:r>
                      <a:r>
                        <a:rPr kumimoji="0" lang="en-GB" altLang="en-US" sz="11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onferoni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orrection (Holm, 1979). Those in bold denote statistically significant associations. </a:t>
                      </a:r>
                      <a:endParaRPr kumimoji="0" lang="en-GB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highlight>
                          <a:srgbClr val="FFFF00"/>
                        </a:highlight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7822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calcar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siliceous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 calcar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 silic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70494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xa richnes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1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4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2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3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8371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T richnes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0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0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2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4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97081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T index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4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1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6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3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35436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SI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6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4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5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5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9734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F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2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5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6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42966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SI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2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8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3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9511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P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20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1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6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6408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PT-ASP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4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3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3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3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1465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ic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6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7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02598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i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41)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6269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v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9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7363296"/>
                  </a:ext>
                </a:extLst>
              </a:tr>
              <a:tr h="877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oQ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0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8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7266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iv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4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803741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919DFB1F-18C3-CD1B-8AC0-9BE855BA52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2956364"/>
              </p:ext>
            </p:extLst>
          </p:nvPr>
        </p:nvGraphicFramePr>
        <p:xfrm>
          <a:off x="423118" y="3294189"/>
          <a:ext cx="5984504" cy="3098483"/>
        </p:xfrm>
        <a:graphic>
          <a:graphicData uri="http://schemas.openxmlformats.org/drawingml/2006/table">
            <a:tbl>
              <a:tblPr firstRow="1" firstCol="1" bandRow="1"/>
              <a:tblGrid>
                <a:gridCol w="1196768">
                  <a:extLst>
                    <a:ext uri="{9D8B030D-6E8A-4147-A177-3AD203B41FA5}">
                      <a16:colId xmlns:a16="http://schemas.microsoft.com/office/drawing/2014/main" val="4232028763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3679117407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2645443702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4174454675"/>
                    </a:ext>
                  </a:extLst>
                </a:gridCol>
                <a:gridCol w="1197432">
                  <a:extLst>
                    <a:ext uri="{9D8B030D-6E8A-4147-A177-3AD203B41FA5}">
                      <a16:colId xmlns:a16="http://schemas.microsoft.com/office/drawing/2014/main" val="207507030"/>
                    </a:ext>
                  </a:extLst>
                </a:gridCol>
              </a:tblGrid>
              <a:tr h="79660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ble S3. 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rwise correlation coefficient between 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xonomic and functional community measures a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d visual fine sediment % for Spring samples. Correlations have been corrected for multiple comparisons using the Holm-</a:t>
                      </a:r>
                      <a:r>
                        <a:rPr kumimoji="0" lang="en-GB" altLang="en-US" sz="11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onferoni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orrection (Holm, 1979). Those in bold denote statistically significant associations. </a:t>
                      </a:r>
                      <a:endParaRPr kumimoji="0" lang="en-GB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7822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calcar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siliceous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 calcar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 silic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70494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xa richnes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2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84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2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7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8371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T richnes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1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4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7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1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97081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T index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4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6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2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9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35436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SI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7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5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6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2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9734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F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3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9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0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0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4296678"/>
                  </a:ext>
                </a:extLst>
              </a:tr>
              <a:tr h="367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SI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2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5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9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5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9511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P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21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2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9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6408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PT-ASP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7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2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6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0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1465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ic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02598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i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6269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v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7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7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7363296"/>
                  </a:ext>
                </a:extLst>
              </a:tr>
              <a:tr h="877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oQ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7266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iv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8037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67208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8C115CB-6ABD-0B83-3A03-74C8189843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4923585"/>
              </p:ext>
            </p:extLst>
          </p:nvPr>
        </p:nvGraphicFramePr>
        <p:xfrm>
          <a:off x="436748" y="359603"/>
          <a:ext cx="5984504" cy="3098483"/>
        </p:xfrm>
        <a:graphic>
          <a:graphicData uri="http://schemas.openxmlformats.org/drawingml/2006/table">
            <a:tbl>
              <a:tblPr firstRow="1" firstCol="1" bandRow="1"/>
              <a:tblGrid>
                <a:gridCol w="1196768">
                  <a:extLst>
                    <a:ext uri="{9D8B030D-6E8A-4147-A177-3AD203B41FA5}">
                      <a16:colId xmlns:a16="http://schemas.microsoft.com/office/drawing/2014/main" val="4232028763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3679117407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2645443702"/>
                    </a:ext>
                  </a:extLst>
                </a:gridCol>
                <a:gridCol w="1196768">
                  <a:extLst>
                    <a:ext uri="{9D8B030D-6E8A-4147-A177-3AD203B41FA5}">
                      <a16:colId xmlns:a16="http://schemas.microsoft.com/office/drawing/2014/main" val="4174454675"/>
                    </a:ext>
                  </a:extLst>
                </a:gridCol>
                <a:gridCol w="1197432">
                  <a:extLst>
                    <a:ext uri="{9D8B030D-6E8A-4147-A177-3AD203B41FA5}">
                      <a16:colId xmlns:a16="http://schemas.microsoft.com/office/drawing/2014/main" val="207507030"/>
                    </a:ext>
                  </a:extLst>
                </a:gridCol>
              </a:tblGrid>
              <a:tr h="79660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en-US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ble S4. 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rwise correlation coefficient between </a:t>
                      </a:r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xonomic and functional community measures a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d visual fine sediment % for Autumn samples. Correlations have been corrected for multiple comparisons using the Holm-</a:t>
                      </a:r>
                      <a:r>
                        <a:rPr kumimoji="0" lang="en-GB" altLang="en-US" sz="11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onferoni</a:t>
                      </a:r>
                      <a:r>
                        <a:rPr kumimoji="0" lang="en-GB" altLang="en-US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orrection (Holm, 1979). Those in bold denote statistically significant associations. </a:t>
                      </a:r>
                      <a:endParaRPr kumimoji="0" lang="en-GB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7822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calcar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siliceous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 calcar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 siliceou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70494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xa richnes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0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9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1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1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8371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T richnes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29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6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68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9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97081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T index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3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7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2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9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35436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SI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5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1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9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8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9734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F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1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03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1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4296678"/>
                  </a:ext>
                </a:extLst>
              </a:tr>
              <a:tr h="367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SI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26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2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5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9511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P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7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21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1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4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6408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PT-ASP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409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322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25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00</a:t>
                      </a: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1465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ic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02598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i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6269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ve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0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4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7363296"/>
                  </a:ext>
                </a:extLst>
              </a:tr>
              <a:tr h="877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oQ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7266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Div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8037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9647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25</TotalTime>
  <Words>846</Words>
  <Application>Microsoft Office PowerPoint</Application>
  <PresentationFormat>On-screen Show (4:3)</PresentationFormat>
  <Paragraphs>306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Mathers</dc:creator>
  <cp:lastModifiedBy>Kate Mathers</cp:lastModifiedBy>
  <cp:revision>7</cp:revision>
  <cp:lastPrinted>2024-05-07T11:01:57Z</cp:lastPrinted>
  <dcterms:created xsi:type="dcterms:W3CDTF">2024-05-03T15:44:37Z</dcterms:created>
  <dcterms:modified xsi:type="dcterms:W3CDTF">2025-10-31T13:15:08Z</dcterms:modified>
</cp:coreProperties>
</file>